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5" r:id="rId2"/>
    <p:sldId id="27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2" userDrawn="1">
          <p15:clr>
            <a:srgbClr val="A4A3A4"/>
          </p15:clr>
        </p15:guide>
        <p15:guide id="2" pos="254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ojin, Bianca B" initials="KBB" lastIdx="13" clrIdx="0">
    <p:extLst>
      <p:ext uri="{19B8F6BF-5375-455C-9EA6-DF929625EA0E}">
        <p15:presenceInfo xmlns:p15="http://schemas.microsoft.com/office/powerpoint/2012/main" userId="Kojin, Bianca B" providerId="None"/>
      </p:ext>
    </p:extLst>
  </p:cmAuthor>
  <p:cmAuthor id="2" name="Adelman, Zachary N" initials="AZN" lastIdx="1" clrIdx="1">
    <p:extLst>
      <p:ext uri="{19B8F6BF-5375-455C-9EA6-DF929625EA0E}">
        <p15:presenceInfo xmlns:p15="http://schemas.microsoft.com/office/powerpoint/2012/main" userId="S-1-5-21-1167378736-2199707310-2242153877-49379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D08"/>
    <a:srgbClr val="7E05FF"/>
    <a:srgbClr val="FF0677"/>
    <a:srgbClr val="2828FF"/>
    <a:srgbClr val="8FFF8F"/>
    <a:srgbClr val="941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237" autoAdjust="0"/>
    <p:restoredTop sz="94660"/>
  </p:normalViewPr>
  <p:slideViewPr>
    <p:cSldViewPr snapToGrid="0" showGuides="1">
      <p:cViewPr>
        <p:scale>
          <a:sx n="142" d="100"/>
          <a:sy n="142" d="100"/>
        </p:scale>
        <p:origin x="-132" y="120"/>
      </p:cViewPr>
      <p:guideLst>
        <p:guide orient="horz" pos="2112"/>
        <p:guide pos="254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A8A54-A8F4-4CE2-BAD2-4651E15F690F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8517-6AA7-429D-87BA-C887474EE7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475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A8A54-A8F4-4CE2-BAD2-4651E15F690F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8517-6AA7-429D-87BA-C887474EE7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824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A8A54-A8F4-4CE2-BAD2-4651E15F690F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8517-6AA7-429D-87BA-C887474EE7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897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A8A54-A8F4-4CE2-BAD2-4651E15F690F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8517-6AA7-429D-87BA-C887474EE7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646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A8A54-A8F4-4CE2-BAD2-4651E15F690F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8517-6AA7-429D-87BA-C887474EE7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187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A8A54-A8F4-4CE2-BAD2-4651E15F690F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8517-6AA7-429D-87BA-C887474EE7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503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A8A54-A8F4-4CE2-BAD2-4651E15F690F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8517-6AA7-429D-87BA-C887474EE7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719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A8A54-A8F4-4CE2-BAD2-4651E15F690F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8517-6AA7-429D-87BA-C887474EE7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915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A8A54-A8F4-4CE2-BAD2-4651E15F690F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8517-6AA7-429D-87BA-C887474EE7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337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A8A54-A8F4-4CE2-BAD2-4651E15F690F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8517-6AA7-429D-87BA-C887474EE7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217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A8A54-A8F4-4CE2-BAD2-4651E15F690F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8517-6AA7-429D-87BA-C887474EE7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5291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EA8A54-A8F4-4CE2-BAD2-4651E15F690F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578517-6AA7-429D-87BA-C887474EE7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993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6724589"/>
              </p:ext>
            </p:extLst>
          </p:nvPr>
        </p:nvGraphicFramePr>
        <p:xfrm>
          <a:off x="1927469" y="131393"/>
          <a:ext cx="9072225" cy="6631868"/>
        </p:xfrm>
        <a:graphic>
          <a:graphicData uri="http://schemas.openxmlformats.org/drawingml/2006/table">
            <a:tbl>
              <a:tblPr firstRow="1" bandRow="1"/>
              <a:tblGrid>
                <a:gridCol w="1284555">
                  <a:extLst>
                    <a:ext uri="{9D8B030D-6E8A-4147-A177-3AD203B41FA5}">
                      <a16:colId xmlns:a16="http://schemas.microsoft.com/office/drawing/2014/main" val="4103526601"/>
                    </a:ext>
                  </a:extLst>
                </a:gridCol>
                <a:gridCol w="5905082">
                  <a:extLst>
                    <a:ext uri="{9D8B030D-6E8A-4147-A177-3AD203B41FA5}">
                      <a16:colId xmlns:a16="http://schemas.microsoft.com/office/drawing/2014/main" val="3435801243"/>
                    </a:ext>
                  </a:extLst>
                </a:gridCol>
                <a:gridCol w="1143964">
                  <a:extLst>
                    <a:ext uri="{9D8B030D-6E8A-4147-A177-3AD203B41FA5}">
                      <a16:colId xmlns:a16="http://schemas.microsoft.com/office/drawing/2014/main" val="2261039371"/>
                    </a:ext>
                  </a:extLst>
                </a:gridCol>
                <a:gridCol w="738624">
                  <a:extLst>
                    <a:ext uri="{9D8B030D-6E8A-4147-A177-3AD203B41FA5}">
                      <a16:colId xmlns:a16="http://schemas.microsoft.com/office/drawing/2014/main" val="115941288"/>
                    </a:ext>
                  </a:extLst>
                </a:gridCol>
              </a:tblGrid>
              <a:tr h="1534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rimer name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rimer sequence (5’-3’)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mplicon size (bp)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fficiency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6191314"/>
                  </a:ext>
                </a:extLst>
              </a:tr>
              <a:tr h="125936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sRNA Experiments</a:t>
                      </a:r>
                      <a:endParaRPr lang="en-US" sz="800" dirty="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8264869"/>
                  </a:ext>
                </a:extLst>
              </a:tr>
              <a:tr h="16791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sSGS1_FOW</a:t>
                      </a:r>
                      <a:endParaRPr lang="en-US" sz="800" dirty="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TAATACGACTCACTATAGGGAGAGATCACCTGCTAAGCCATCC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6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3455986"/>
                  </a:ext>
                </a:extLst>
              </a:tr>
              <a:tr h="16791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sSGS1_REV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TAATACGACTCACTATAGGGAGACCCAACCTGGAACACTCACA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6165200"/>
                  </a:ext>
                </a:extLst>
              </a:tr>
              <a:tr h="16791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sEGFP_FOW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TAATACGACTCACTATAGGGAGACCTGAAGTTCATCTGCACCA 3’</a:t>
                      </a:r>
                      <a:endParaRPr lang="en-US" sz="800" dirty="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82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7262064"/>
                  </a:ext>
                </a:extLst>
              </a:tr>
              <a:tr h="167914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sEGFP_REV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TAATACGACTCACTATAGGGAGAGTTGTGGCGGATCTTGAAGT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2803284"/>
                  </a:ext>
                </a:extLst>
              </a:tr>
              <a:tr h="125936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T-PCR Experiments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509634"/>
                  </a:ext>
                </a:extLst>
              </a:tr>
              <a:tr h="125936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GS1-FOW 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GATCACCTGCTAAGCCATCC 3’</a:t>
                      </a:r>
                      <a:endParaRPr lang="en-US" sz="800" dirty="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6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1348721"/>
                  </a:ext>
                </a:extLst>
              </a:tr>
              <a:tr h="125936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GS1-REV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CCCAACCCCCCTGGAACACTCACA 3’</a:t>
                      </a:r>
                      <a:endParaRPr lang="en-US" sz="800" dirty="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0939418"/>
                  </a:ext>
                </a:extLst>
              </a:tr>
              <a:tr h="125936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CT-FOW 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GAGCGTGGCTACTCCTTCAC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9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9195118"/>
                  </a:ext>
                </a:extLst>
              </a:tr>
              <a:tr h="125936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CT-REV 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AGTTTCGTGGATACCGCAAG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9946609"/>
                  </a:ext>
                </a:extLst>
              </a:tr>
              <a:tr h="125936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T-qPCR Experiment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97563041"/>
                  </a:ext>
                </a:extLst>
              </a:tr>
              <a:tr h="125936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qSG1B_FOW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ACAAGCTGATGGGGAAAGTG 3’ </a:t>
                      </a:r>
                      <a:endParaRPr lang="en-US" sz="800" dirty="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3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2%</a:t>
                      </a:r>
                      <a:endParaRPr lang="en-US" sz="800" dirty="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7416560"/>
                  </a:ext>
                </a:extLst>
              </a:tr>
              <a:tr h="125936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qSGS1B_REV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CATCTCCTCGTTGTCCGTTT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23144224"/>
                  </a:ext>
                </a:extLst>
              </a:tr>
              <a:tr h="125936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qSGS1_FOW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GGGACGGGATTGTATTGTGC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9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%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6853274"/>
                  </a:ext>
                </a:extLst>
              </a:tr>
              <a:tr h="125936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qSGS1_REV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TGTCCAATCTCTCTCCAGCC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55015326"/>
                  </a:ext>
                </a:extLst>
              </a:tr>
              <a:tr h="125936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qrpS7_FOW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</a:t>
                      </a:r>
                      <a:r>
                        <a:rPr lang="en-US" sz="800" kern="1200" cap="all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ccgccgtctacgatgcca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1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4%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5792473"/>
                  </a:ext>
                </a:extLst>
              </a:tr>
              <a:tr h="125936"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qrpS7_REV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</a:t>
                      </a:r>
                      <a:r>
                        <a:rPr lang="en-US" sz="800" kern="1200" cap="all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ggtggtctgctggttctt3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1989247"/>
                  </a:ext>
                </a:extLst>
              </a:tr>
              <a:tr h="125936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RISPR/Cas9 Knockout lines generation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0181359"/>
                  </a:ext>
                </a:extLst>
              </a:tr>
              <a:tr h="377807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gRNA 1.1 9993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GAAATTAATACGACTCACTATAGGGGTGGATCTCCAGGGACGAAGTTTTAGAGCTAGAAA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8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766045"/>
                  </a:ext>
                </a:extLst>
              </a:tr>
              <a:tr h="377807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gRNA 1.2 9993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GAAATTAATACGACTCACTATAGGGGGACTACC GATCAAGCTCGGTTTTAGAGCTAGAAA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8767595"/>
                  </a:ext>
                </a:extLst>
              </a:tr>
              <a:tr h="377807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gRNA 1.3 9993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GAAATTAATACGACTCACTATAGGGGAGAGGATATGAGTGTTCTGTTTTAGAGCTAGAAA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4421232"/>
                  </a:ext>
                </a:extLst>
              </a:tr>
              <a:tr h="377807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gRNA REV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AAAAGCACCGACTCGGTGCCACTTTTTCAAGTTGATAACGGACTAGCCTTATTTTAACTTGCTATTTCTAGCTCTAAAAC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8889242"/>
                  </a:ext>
                </a:extLst>
              </a:tr>
              <a:tr h="125936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993 Fow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AGTGGTGCTCTTAGTAAACC 3’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2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5001361"/>
                  </a:ext>
                </a:extLst>
              </a:tr>
              <a:tr h="125936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993 Rev</a:t>
                      </a:r>
                      <a:endParaRPr lang="en-US" sz="80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’ CCGGATCTTACCATCACTTA 3’</a:t>
                      </a:r>
                      <a:endParaRPr lang="en-US" sz="800" dirty="0">
                        <a:solidFill>
                          <a:srgbClr val="00000A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419" marR="3541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6889795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E9D0D5F3-7537-E147-905C-C2EE250FD36D}"/>
              </a:ext>
            </a:extLst>
          </p:cNvPr>
          <p:cNvSpPr txBox="1"/>
          <p:nvPr/>
        </p:nvSpPr>
        <p:spPr>
          <a:xfrm>
            <a:off x="0" y="26084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89377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5468573" y="1983873"/>
            <a:ext cx="6303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=0.1181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0021" y="2018058"/>
            <a:ext cx="2007092" cy="2128928"/>
          </a:xfrm>
          <a:prstGeom prst="rect">
            <a:avLst/>
          </a:prstGeom>
        </p:spPr>
      </p:pic>
      <p:sp>
        <p:nvSpPr>
          <p:cNvPr id="8" name="Right Bracket 7"/>
          <p:cNvSpPr/>
          <p:nvPr/>
        </p:nvSpPr>
        <p:spPr>
          <a:xfrm rot="16200000" flipV="1">
            <a:off x="5759979" y="1929114"/>
            <a:ext cx="60170" cy="54860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9D0D5F3-7537-E147-905C-C2EE250FD36D}"/>
              </a:ext>
            </a:extLst>
          </p:cNvPr>
          <p:cNvSpPr txBox="1"/>
          <p:nvPr/>
        </p:nvSpPr>
        <p:spPr>
          <a:xfrm>
            <a:off x="0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24692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01</TotalTime>
  <Words>174</Words>
  <Application>Microsoft Office PowerPoint</Application>
  <PresentationFormat>Widescreen</PresentationFormat>
  <Paragraphs>6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Texas A&amp;M - Agriculture &amp; Life Scien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jin, Bianca B</dc:creator>
  <cp:lastModifiedBy>Adelman, Zachary N</cp:lastModifiedBy>
  <cp:revision>247</cp:revision>
  <dcterms:created xsi:type="dcterms:W3CDTF">2020-01-24T21:27:10Z</dcterms:created>
  <dcterms:modified xsi:type="dcterms:W3CDTF">2020-11-18T17:09:28Z</dcterms:modified>
</cp:coreProperties>
</file>